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2" d="100"/>
          <a:sy n="52" d="100"/>
        </p:scale>
        <p:origin x="-1790" y="-9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06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910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968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641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662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973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72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4044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340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1803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9693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A60B0-F07B-43E5-B52D-FDEB9C744D48}" type="datetimeFigureOut">
              <a:rPr lang="en-GB" smtClean="0"/>
              <a:t>28/05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238CB-F06F-463C-8EAC-8967E2F7A4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457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1768122"/>
              </p:ext>
            </p:extLst>
          </p:nvPr>
        </p:nvGraphicFramePr>
        <p:xfrm>
          <a:off x="188640" y="308780"/>
          <a:ext cx="6408712" cy="8781755"/>
        </p:xfrm>
        <a:graphic>
          <a:graphicData uri="http://schemas.openxmlformats.org/drawingml/2006/table">
            <a:tbl>
              <a:tblPr/>
              <a:tblGrid>
                <a:gridCol w="1511732"/>
                <a:gridCol w="981979"/>
                <a:gridCol w="2041486"/>
                <a:gridCol w="1873515"/>
              </a:tblGrid>
              <a:tr h="248538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IF2 Signalling</a:t>
                      </a:r>
                    </a:p>
                  </a:txBody>
                  <a:tcPr marL="4055" marR="4055" marT="40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 Signalling</a:t>
                      </a:r>
                    </a:p>
                  </a:txBody>
                  <a:tcPr marL="4055" marR="4055" marT="40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le of PRRs in </a:t>
                      </a:r>
                      <a:b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cognition of Bacteria &amp; Viruses</a:t>
                      </a:r>
                    </a:p>
                  </a:txBody>
                  <a:tcPr marL="4055" marR="4055" marT="40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tigen Presentation Pathway</a:t>
                      </a:r>
                    </a:p>
                  </a:txBody>
                  <a:tcPr marL="4055" marR="4055" marT="40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Sribosomal subunit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k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ß-</a:t>
                      </a:r>
                      <a:r>
                        <a:rPr lang="en-GB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a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m-Mhc1a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S PreinitiationComplex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x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q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m-Mhc1a-peptide fragment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cl-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L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S ribosomalsubunit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RIP150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a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74-Mhc2a-Mhc2b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12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IP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5a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IITA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KT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IP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5a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IP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-Raf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corticoid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sp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NX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IF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35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EB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γ</a:t>
                      </a:r>
                      <a:endParaRPr lang="el-G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IF4A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CTIN-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MP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IF5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CTIN-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MP7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2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ITM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IF-2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MPX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2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/</a:t>
                      </a: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K1/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MPY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2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γ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γ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/</a:t>
                      </a: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HC I-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γ</a:t>
                      </a: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-1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HC I-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4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γ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γ</a:t>
                      </a: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-10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HC II-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4C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AR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-1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HC II-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4E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AR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-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hc2a-Mhc2b-peptide fragment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F4F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F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-6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LRC5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K1/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F9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PAF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IA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DD34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GF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F-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ptide-Tap1-Tap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DD34-PP1c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K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F-7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smb5-Psmb6-Psmb8-Psmb9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N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K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F3/7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P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DP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X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NK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P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B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F-ĸBp65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P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PN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SK3ß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BL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TP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AS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DA-5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RI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SMB8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D88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OCS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LP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ulin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F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κ</a:t>
                      </a: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K1/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1 dime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D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t-tRNA-eIF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1-Stat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D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BP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A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K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P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ptidoglycan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RK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C-PTP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3K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3K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YK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KC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K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KR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P1c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C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γ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X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HC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NTE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O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IG-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IP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NAse L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S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YK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1-TLR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11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2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3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4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5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6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7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8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LR9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F-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α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AF6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IF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ISA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3198"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Zymosan</a:t>
                      </a: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055" marR="4055" marT="40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785" y="-3651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11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610662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04</Words>
  <Application>Microsoft Office PowerPoint</Application>
  <PresentationFormat>On-screen Show (4:3)</PresentationFormat>
  <Paragraphs>16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1</cp:revision>
  <dcterms:created xsi:type="dcterms:W3CDTF">2013-05-28T15:47:56Z</dcterms:created>
  <dcterms:modified xsi:type="dcterms:W3CDTF">2013-05-28T15:51:43Z</dcterms:modified>
</cp:coreProperties>
</file>